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2" r:id="rId3"/>
    <p:sldId id="263" r:id="rId4"/>
  </p:sldIdLst>
  <p:sldSz cx="12192000" cy="6858000"/>
  <p:notesSz cx="6858000" cy="9144000"/>
  <p:defaultTextStyle>
    <a:defPPr>
      <a:defRPr lang="nb-SJ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4660"/>
  </p:normalViewPr>
  <p:slideViewPr>
    <p:cSldViewPr snapToGrid="0">
      <p:cViewPr varScale="1">
        <p:scale>
          <a:sx n="59" d="100"/>
          <a:sy n="59" d="100"/>
        </p:scale>
        <p:origin x="84" y="2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92C803-FF5E-EF83-DD34-6E8A14C9013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4922320-F9E6-5F39-947B-EE96B83873D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6CAA1C-F7ED-B277-F7C3-0E86822DE0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A2BE4-55AD-4F9B-A14F-517C330D1A05}" type="datetimeFigureOut">
              <a:rPr lang="en-GB" smtClean="0"/>
              <a:t>30/09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AC0CF8-D59F-BDD1-F09E-4DFAEF5C9C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9224A7-8D43-31C3-29E3-E93A539059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D6D751-A75B-46C7-AB7A-0968026134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4163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BAE8FD-4A4C-5D81-558A-5281039B45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D8CC282-38F0-522A-DA22-A497F8EA96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4E56D2-E1AB-EE79-96A3-8186AC4B62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A2BE4-55AD-4F9B-A14F-517C330D1A05}" type="datetimeFigureOut">
              <a:rPr lang="en-GB" smtClean="0"/>
              <a:t>30/09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E52B24-C4D5-3B1F-653A-23B071367E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AFBCEF-0979-3471-26CC-4E4CEB600E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D6D751-A75B-46C7-AB7A-0968026134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1094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D42B6C0-3131-56E0-E12D-DC5F40047A9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855DD4-227B-BE20-C5FF-2C303617B7C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B7F26A-6DA3-5F7A-A72A-611A2217E0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A2BE4-55AD-4F9B-A14F-517C330D1A05}" type="datetimeFigureOut">
              <a:rPr lang="en-GB" smtClean="0"/>
              <a:t>30/09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46632B-3F52-FD9C-5F89-79DB01FBD2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8FAB04-8EEF-90E1-19EC-A50A0CD3DA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D6D751-A75B-46C7-AB7A-0968026134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7482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F34C00-97E9-FE09-E695-E37742459D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D74993-5E44-3163-7DAC-57F1934469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97A561-26EE-4F43-F9B9-F2D68B5757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A2BE4-55AD-4F9B-A14F-517C330D1A05}" type="datetimeFigureOut">
              <a:rPr lang="en-GB" smtClean="0"/>
              <a:t>30/09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68D595-238E-47F3-CB50-29B04730FE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9618B2-6F91-567C-7087-496E716224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D6D751-A75B-46C7-AB7A-0968026134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3443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B3EA27-C2D0-837D-A601-57B726B70F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E4206ED-949D-9188-5EC9-54A66B83CD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436C41-625C-25D0-96FA-8873710E35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A2BE4-55AD-4F9B-A14F-517C330D1A05}" type="datetimeFigureOut">
              <a:rPr lang="en-GB" smtClean="0"/>
              <a:t>30/09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A7D1F1-9278-F5AC-D081-72600F55BF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191758-F257-7E8E-5984-F67CD7954C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D6D751-A75B-46C7-AB7A-0968026134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93963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9E44C2-C2E3-EE6E-BD8F-5E3DF17843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09CD27-67C1-1EB5-5BF2-675358BE480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853BA65-5252-9136-FBB7-A2959D001FE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8986E3-C5E2-27CB-8E11-CFAFC1EF10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A2BE4-55AD-4F9B-A14F-517C330D1A05}" type="datetimeFigureOut">
              <a:rPr lang="en-GB" smtClean="0"/>
              <a:t>30/09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42DF18F-9E91-A0E1-DA7A-2234EFE4AA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37CEC33-B288-1A9B-0612-DD0F1D669F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D6D751-A75B-46C7-AB7A-0968026134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446460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6FA8AD-0E8E-F89E-2F90-F8E2EE0861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E94D27C-5DF5-F9EE-8FB8-0AFFF89B1B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4778FD5-E27A-066A-A785-6004D92368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D9840FF-FD81-CBE4-3AFD-9FBD4E2DD5F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0E9037B-85E1-0439-EAF1-481828FF73D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7BBDC4F-3172-C81A-4580-6DB4AC7AD7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A2BE4-55AD-4F9B-A14F-517C330D1A05}" type="datetimeFigureOut">
              <a:rPr lang="en-GB" smtClean="0"/>
              <a:t>30/09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FE06D6C-74B5-BC0F-F090-B850C06BD3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FDC06E-D8EE-B882-8D3A-C7E142626F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D6D751-A75B-46C7-AB7A-0968026134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95975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69A055-02C8-868C-85BB-E6952BE174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3338202-04CB-FF5E-D1C1-DC38B13783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A2BE4-55AD-4F9B-A14F-517C330D1A05}" type="datetimeFigureOut">
              <a:rPr lang="en-GB" smtClean="0"/>
              <a:t>30/09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77CBE60-D0BD-E996-1B47-B594CF39DC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A912F18-B0FF-D2E3-06CA-DB8F37CE5A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D6D751-A75B-46C7-AB7A-0968026134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42426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78E4151-2A52-2E82-5513-70A517B8B0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A2BE4-55AD-4F9B-A14F-517C330D1A05}" type="datetimeFigureOut">
              <a:rPr lang="en-GB" smtClean="0"/>
              <a:t>30/09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787799E-0611-25C5-5383-40DEDFC90B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2CB4BE1-91E3-2DEE-B64B-D01D4F5A37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D6D751-A75B-46C7-AB7A-0968026134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53546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2B970F-B950-946B-151C-19400D372A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D3AE6B-8F91-3E87-40E7-29D83909536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5FD4C44-E7A5-89C8-6D31-CC83507682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EBB7E96-D2E0-77FA-018E-A8F477E6B1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A2BE4-55AD-4F9B-A14F-517C330D1A05}" type="datetimeFigureOut">
              <a:rPr lang="en-GB" smtClean="0"/>
              <a:t>30/09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AFDFE6-7B7C-D5FC-3815-47D3FB0822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97EF96-5990-1B67-5409-91ECA5441E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D6D751-A75B-46C7-AB7A-0968026134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913978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461B42-61DA-4CE4-DA3F-59BF14F482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CF2B2B0-D452-7301-C9A4-C23A8ED1168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87BDA5E-8827-D007-AD9F-1188377F14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55D696-A510-6638-01E5-F8CCEF5ED2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0A2BE4-55AD-4F9B-A14F-517C330D1A05}" type="datetimeFigureOut">
              <a:rPr lang="en-GB" smtClean="0"/>
              <a:t>30/09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9FCD3D-306A-80C5-EC98-CDD3287ED5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F6A4F5-6719-C5D5-36F5-7404147AAA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D6D751-A75B-46C7-AB7A-0968026134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3939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01F26A3-5722-CD1F-1251-5FDF8F5747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94B13D-6364-502E-0DDE-4D77B91FC9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5ADF36-478B-AE61-BAD3-E322B181B61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A0A2BE4-55AD-4F9B-A14F-517C330D1A05}" type="datetimeFigureOut">
              <a:rPr lang="en-GB" smtClean="0"/>
              <a:t>30/09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4DADA2-AF1B-90F6-1B6C-E9530E7BEB9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A62D25-9B65-1555-E92E-3640B64A68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7D6D751-A75B-46C7-AB7A-09680261340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87738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b-SJ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Box 18">
            <a:extLst>
              <a:ext uri="{FF2B5EF4-FFF2-40B4-BE49-F238E27FC236}">
                <a16:creationId xmlns:a16="http://schemas.microsoft.com/office/drawing/2014/main" id="{D4D4A1E2-8EF8-54D0-7BE9-91E312121650}"/>
              </a:ext>
            </a:extLst>
          </p:cNvPr>
          <p:cNvSpPr txBox="1"/>
          <p:nvPr/>
        </p:nvSpPr>
        <p:spPr>
          <a:xfrm>
            <a:off x="1262284" y="6106961"/>
            <a:ext cx="96674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almon gut microbiota differ in diversity across developmental phases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. (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) Box plots showing Observed ASV (natural log transformed) and (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) Shannon diversity across timepoints (representing wild and farmed salmon from all countries). The jittered dots represent individual values of samples. 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B0AE2443-CAF1-4381-2730-33E58B133B30}"/>
              </a:ext>
            </a:extLst>
          </p:cNvPr>
          <p:cNvGrpSpPr/>
          <p:nvPr/>
        </p:nvGrpSpPr>
        <p:grpSpPr>
          <a:xfrm>
            <a:off x="4118335" y="291153"/>
            <a:ext cx="3686560" cy="5651025"/>
            <a:chOff x="4118335" y="291153"/>
            <a:chExt cx="3686560" cy="5651025"/>
          </a:xfrm>
        </p:grpSpPr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657444E3-DF50-D2E7-96C0-500A1AF2B550}"/>
                </a:ext>
              </a:extLst>
            </p:cNvPr>
            <p:cNvGrpSpPr/>
            <p:nvPr/>
          </p:nvGrpSpPr>
          <p:grpSpPr>
            <a:xfrm>
              <a:off x="4206571" y="302443"/>
              <a:ext cx="3598324" cy="5639735"/>
              <a:chOff x="7965548" y="-423303"/>
              <a:chExt cx="3598324" cy="5639735"/>
            </a:xfrm>
          </p:grpSpPr>
          <p:pic>
            <p:nvPicPr>
              <p:cNvPr id="5" name="Picture 4" descr="A graph of blue squares and black dots&#10;&#10;AI-generated content may be incorrect.">
                <a:extLst>
                  <a:ext uri="{FF2B5EF4-FFF2-40B4-BE49-F238E27FC236}">
                    <a16:creationId xmlns:a16="http://schemas.microsoft.com/office/drawing/2014/main" id="{5A5E0532-9E8E-4299-76FD-467AC8D181C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965548" y="-423303"/>
                <a:ext cx="3598324" cy="2970344"/>
              </a:xfrm>
              <a:prstGeom prst="rect">
                <a:avLst/>
              </a:prstGeom>
            </p:spPr>
          </p:pic>
          <p:pic>
            <p:nvPicPr>
              <p:cNvPr id="6" name="Picture 5" descr="A diagram of a phase&#10;&#10;AI-generated content may be incorrect.">
                <a:extLst>
                  <a:ext uri="{FF2B5EF4-FFF2-40B4-BE49-F238E27FC236}">
                    <a16:creationId xmlns:a16="http://schemas.microsoft.com/office/drawing/2014/main" id="{40DAD68F-10C8-001A-0295-E99CF9F5193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121478" y="2246088"/>
                <a:ext cx="3442394" cy="2970344"/>
              </a:xfrm>
              <a:prstGeom prst="rect">
                <a:avLst/>
              </a:prstGeom>
            </p:spPr>
          </p:pic>
        </p:grp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6150B9B6-EBFC-4AD6-C49B-5F7BAB3AF5E9}"/>
                </a:ext>
              </a:extLst>
            </p:cNvPr>
            <p:cNvSpPr txBox="1"/>
            <p:nvPr/>
          </p:nvSpPr>
          <p:spPr>
            <a:xfrm>
              <a:off x="4118335" y="291153"/>
              <a:ext cx="293610" cy="3211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C6C3316-0F15-3817-52DA-DD0DC4E6A705}"/>
                </a:ext>
              </a:extLst>
            </p:cNvPr>
            <p:cNvSpPr txBox="1"/>
            <p:nvPr/>
          </p:nvSpPr>
          <p:spPr>
            <a:xfrm>
              <a:off x="4118335" y="2950493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950338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96701" y="830511"/>
            <a:ext cx="4970602" cy="3944922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548286" y="5748642"/>
            <a:ext cx="96674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Wild salmon gut microbiota differ in composition across countries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. The </a:t>
            </a:r>
            <a:r>
              <a:rPr lang="en-GB" sz="1000" dirty="0" err="1">
                <a:latin typeface="Arial" panose="020B0604020202020204" pitchFamily="34" charset="0"/>
                <a:cs typeface="Arial" panose="020B0604020202020204" pitchFamily="34" charset="0"/>
              </a:rPr>
              <a:t>PCoA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 plot reflecting microbial community compositions of gut microbiota of wild salmon from Ireland, Norway and Scotland. Percentages of explained variance by each principal axis are indicated in square brackets. </a:t>
            </a:r>
          </a:p>
        </p:txBody>
      </p:sp>
    </p:spTree>
    <p:extLst>
      <p:ext uri="{BB962C8B-B14F-4D97-AF65-F5344CB8AC3E}">
        <p14:creationId xmlns:p14="http://schemas.microsoft.com/office/powerpoint/2010/main" val="19179194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48286" y="5748642"/>
            <a:ext cx="96674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Farmed salmon gut microbiota differ in diversity in successive developmental phases across countries</a:t>
            </a: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. The box plot reflecting microbial diversity- Observed ASVs (natural log transformed) of farmed salmon across successive developmental phases from Ireland, Norway and Scotland. </a:t>
            </a:r>
          </a:p>
        </p:txBody>
      </p:sp>
      <p:pic>
        <p:nvPicPr>
          <p:cNvPr id="3" name="Picture 2" descr="A diagram of different types of candlesticks&#10;&#10;AI-generated content may be incorrect.">
            <a:extLst>
              <a:ext uri="{FF2B5EF4-FFF2-40B4-BE49-F238E27FC236}">
                <a16:creationId xmlns:a16="http://schemas.microsoft.com/office/drawing/2014/main" id="{1C6E4C8C-1C8D-EEE1-5472-3D862CFEE65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5933" y="1151626"/>
            <a:ext cx="5960134" cy="39734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061305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9</Words>
  <Application>Microsoft Office PowerPoint</Application>
  <PresentationFormat>Widescreen</PresentationFormat>
  <Paragraphs>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>V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Wasimuddin, NFN</dc:creator>
  <cp:lastModifiedBy>Wasimuddin, NFN</cp:lastModifiedBy>
  <cp:revision>1</cp:revision>
  <dcterms:created xsi:type="dcterms:W3CDTF">2025-09-30T10:32:31Z</dcterms:created>
  <dcterms:modified xsi:type="dcterms:W3CDTF">2025-09-30T10:33:17Z</dcterms:modified>
</cp:coreProperties>
</file>